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4.wmf" ContentType="image/x-wmf"/>
  <Override PartName="/ppt/media/image2.jpeg" ContentType="image/jpeg"/>
  <Override PartName="/ppt/media/image3.jpeg" ContentType="image/jpeg"/>
  <Override PartName="/ppt/media/image5.wmf" ContentType="image/x-wmf"/>
  <Override PartName="/ppt/media/image6.wmf" ContentType="image/x-wmf"/>
  <Override PartName="/ppt/media/image7.wmf" ContentType="image/x-wmf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8C0B7-B955-45CF-B719-CACA6200ABC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1C410-626A-43CB-B82B-BC4DEC8FE2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5B0A66-FFF8-4E93-9FA9-4828CBB404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1D959-2A7C-45B6-BEF5-37F7771C48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D58A6-C796-47CE-8503-EFEDA8A0ED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513742-CB30-4C20-8BF8-C2658C28AD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CBF00-9116-4E97-90AB-C00C42CDA7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2E271-C888-4A2D-907E-0DBE016B6D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D11BE-BE3D-4B6A-B854-8CCA054578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37D3DC-7A9A-4699-ADD2-A923E1D6C5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3F357-DB22-4AD7-83B5-3DA3AB1F83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F41A8A-0968-4A97-9E25-1CA1973033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v-S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E6E1F7-087E-4C71-9B6F-F35AF9BFD03C}" type="slidenum">
              <a:rPr b="0" lang="sv-S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1.jpeg"/><Relationship Id="rId5" Type="http://schemas.openxmlformats.org/officeDocument/2006/relationships/image" Target="../media/image3.jpeg"/><Relationship Id="rId6" Type="http://schemas.openxmlformats.org/officeDocument/2006/relationships/image" Target="../media/image3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5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7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7"/>
          <p:cNvSpPr/>
          <p:nvPr/>
        </p:nvSpPr>
        <p:spPr>
          <a:xfrm>
            <a:off x="1979640" y="907920"/>
            <a:ext cx="76320" cy="406440"/>
          </a:xfrm>
          <a:prstGeom prst="rect">
            <a:avLst/>
          </a:prstGeom>
          <a:solidFill>
            <a:srgbClr val="ff0000">
              <a:alpha val="70000"/>
            </a:srgbClr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"/>
          <p:cNvSpPr/>
          <p:nvPr/>
        </p:nvSpPr>
        <p:spPr>
          <a:xfrm>
            <a:off x="0" y="0"/>
            <a:ext cx="249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3"/>
          <p:cNvSpPr/>
          <p:nvPr/>
        </p:nvSpPr>
        <p:spPr>
          <a:xfrm>
            <a:off x="581760" y="1260360"/>
            <a:ext cx="48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"/>
          <p:cNvSpPr/>
          <p:nvPr/>
        </p:nvSpPr>
        <p:spPr>
          <a:xfrm>
            <a:off x="1232640" y="1260360"/>
            <a:ext cx="48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"/>
          <p:cNvSpPr/>
          <p:nvPr/>
        </p:nvSpPr>
        <p:spPr>
          <a:xfrm>
            <a:off x="1927080" y="126360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½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6"/>
          <p:cNvSpPr/>
          <p:nvPr/>
        </p:nvSpPr>
        <p:spPr>
          <a:xfrm>
            <a:off x="2058480" y="954000"/>
            <a:ext cx="532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oc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7"/>
          <p:cNvSpPr/>
          <p:nvPr/>
        </p:nvSpPr>
        <p:spPr>
          <a:xfrm>
            <a:off x="2083680" y="1674720"/>
            <a:ext cx="99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mitted shoc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8"/>
          <p:cNvSpPr/>
          <p:nvPr/>
        </p:nvSpPr>
        <p:spPr>
          <a:xfrm>
            <a:off x="2034000" y="2324160"/>
            <a:ext cx="100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afe no Shoc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9"/>
          <p:cNvSpPr/>
          <p:nvPr/>
        </p:nvSpPr>
        <p:spPr>
          <a:xfrm>
            <a:off x="581040" y="1311120"/>
            <a:ext cx="0" cy="10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0"/>
          <p:cNvSpPr/>
          <p:nvPr/>
        </p:nvSpPr>
        <p:spPr>
          <a:xfrm>
            <a:off x="1981080" y="1311120"/>
            <a:ext cx="0" cy="10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1"/>
          <p:cNvSpPr/>
          <p:nvPr/>
        </p:nvSpPr>
        <p:spPr>
          <a:xfrm>
            <a:off x="1047600" y="1311120"/>
            <a:ext cx="0" cy="10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4464" descr="C:\Users\Moh\Desktop\Moh\fc pic\CX1-CSr.jpg"/>
          <p:cNvPicPr/>
          <p:nvPr/>
        </p:nvPicPr>
        <p:blipFill>
          <a:blip r:embed="rId1"/>
          <a:srcRect l="0" t="1050" r="0" b="8924"/>
          <a:stretch/>
        </p:blipFill>
        <p:spPr>
          <a:xfrm>
            <a:off x="1320840" y="915840"/>
            <a:ext cx="393840" cy="2476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4229" descr="blue office"/>
          <p:cNvPicPr/>
          <p:nvPr/>
        </p:nvPicPr>
        <p:blipFill>
          <a:blip r:embed="rId2"/>
          <a:stretch/>
        </p:blipFill>
        <p:spPr>
          <a:xfrm>
            <a:off x="1320840" y="2281320"/>
            <a:ext cx="393840" cy="2476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4228" descr="darkroom"/>
          <p:cNvPicPr/>
          <p:nvPr/>
        </p:nvPicPr>
        <p:blipFill>
          <a:blip r:embed="rId3"/>
          <a:stretch/>
        </p:blipFill>
        <p:spPr>
          <a:xfrm>
            <a:off x="619200" y="915840"/>
            <a:ext cx="395280" cy="246240"/>
          </a:xfrm>
          <a:prstGeom prst="rect">
            <a:avLst/>
          </a:prstGeom>
          <a:ln w="0">
            <a:noFill/>
          </a:ln>
        </p:spPr>
      </p:pic>
      <p:sp>
        <p:nvSpPr>
          <p:cNvPr id="55" name="Line 15"/>
          <p:cNvSpPr/>
          <p:nvPr/>
        </p:nvSpPr>
        <p:spPr>
          <a:xfrm flipV="1">
            <a:off x="581040" y="1168560"/>
            <a:ext cx="38160" cy="142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6"/>
          <p:cNvSpPr/>
          <p:nvPr/>
        </p:nvSpPr>
        <p:spPr>
          <a:xfrm flipH="1" flipV="1">
            <a:off x="1009440" y="1168200"/>
            <a:ext cx="3780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7"/>
          <p:cNvSpPr/>
          <p:nvPr/>
        </p:nvSpPr>
        <p:spPr>
          <a:xfrm flipV="1">
            <a:off x="1047600" y="1168560"/>
            <a:ext cx="273240" cy="142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8"/>
          <p:cNvSpPr/>
          <p:nvPr/>
        </p:nvSpPr>
        <p:spPr>
          <a:xfrm flipH="1" flipV="1">
            <a:off x="1708200" y="1168560"/>
            <a:ext cx="272880" cy="142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9"/>
          <p:cNvSpPr/>
          <p:nvPr/>
        </p:nvSpPr>
        <p:spPr>
          <a:xfrm>
            <a:off x="581040" y="1992240"/>
            <a:ext cx="0" cy="10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0"/>
          <p:cNvSpPr/>
          <p:nvPr/>
        </p:nvSpPr>
        <p:spPr>
          <a:xfrm>
            <a:off x="1981080" y="1992240"/>
            <a:ext cx="0" cy="10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1"/>
          <p:cNvSpPr/>
          <p:nvPr/>
        </p:nvSpPr>
        <p:spPr>
          <a:xfrm>
            <a:off x="1047600" y="1992240"/>
            <a:ext cx="0" cy="108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4464" descr="C:\Users\Moh\Desktop\Moh\fc pic\CX1-CSr.jpg"/>
          <p:cNvPicPr/>
          <p:nvPr/>
        </p:nvPicPr>
        <p:blipFill>
          <a:blip r:embed="rId4"/>
          <a:srcRect l="0" t="1050" r="0" b="8924"/>
          <a:stretch/>
        </p:blipFill>
        <p:spPr>
          <a:xfrm>
            <a:off x="1320840" y="1595520"/>
            <a:ext cx="393840" cy="24768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4228" descr="darkroom"/>
          <p:cNvPicPr/>
          <p:nvPr/>
        </p:nvPicPr>
        <p:blipFill>
          <a:blip r:embed="rId5"/>
          <a:stretch/>
        </p:blipFill>
        <p:spPr>
          <a:xfrm>
            <a:off x="619200" y="1595520"/>
            <a:ext cx="395280" cy="247680"/>
          </a:xfrm>
          <a:prstGeom prst="rect">
            <a:avLst/>
          </a:prstGeom>
          <a:ln w="0">
            <a:noFill/>
          </a:ln>
        </p:spPr>
      </p:pic>
      <p:sp>
        <p:nvSpPr>
          <p:cNvPr id="64" name="Line 24"/>
          <p:cNvSpPr/>
          <p:nvPr/>
        </p:nvSpPr>
        <p:spPr>
          <a:xfrm flipV="1">
            <a:off x="581040" y="1847520"/>
            <a:ext cx="3816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5"/>
          <p:cNvSpPr/>
          <p:nvPr/>
        </p:nvSpPr>
        <p:spPr>
          <a:xfrm flipH="1" flipV="1">
            <a:off x="1009440" y="1847520"/>
            <a:ext cx="3780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6"/>
          <p:cNvSpPr/>
          <p:nvPr/>
        </p:nvSpPr>
        <p:spPr>
          <a:xfrm flipV="1">
            <a:off x="1047600" y="1847520"/>
            <a:ext cx="27324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7"/>
          <p:cNvSpPr/>
          <p:nvPr/>
        </p:nvSpPr>
        <p:spPr>
          <a:xfrm flipH="1" flipV="1">
            <a:off x="1708200" y="1847520"/>
            <a:ext cx="272880" cy="144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28"/>
          <p:cNvSpPr/>
          <p:nvPr/>
        </p:nvSpPr>
        <p:spPr>
          <a:xfrm>
            <a:off x="581040" y="2671920"/>
            <a:ext cx="0" cy="107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29"/>
          <p:cNvSpPr/>
          <p:nvPr/>
        </p:nvSpPr>
        <p:spPr>
          <a:xfrm>
            <a:off x="1981080" y="2671920"/>
            <a:ext cx="0" cy="107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0"/>
          <p:cNvSpPr/>
          <p:nvPr/>
        </p:nvSpPr>
        <p:spPr>
          <a:xfrm>
            <a:off x="1047600" y="2671920"/>
            <a:ext cx="0" cy="107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4228" descr="darkroom"/>
          <p:cNvPicPr/>
          <p:nvPr/>
        </p:nvPicPr>
        <p:blipFill>
          <a:blip r:embed="rId6"/>
          <a:stretch/>
        </p:blipFill>
        <p:spPr>
          <a:xfrm>
            <a:off x="619200" y="2276640"/>
            <a:ext cx="395280" cy="245880"/>
          </a:xfrm>
          <a:prstGeom prst="rect">
            <a:avLst/>
          </a:prstGeom>
          <a:ln w="0">
            <a:noFill/>
          </a:ln>
        </p:spPr>
      </p:pic>
      <p:sp>
        <p:nvSpPr>
          <p:cNvPr id="72" name="Line 32"/>
          <p:cNvSpPr/>
          <p:nvPr/>
        </p:nvSpPr>
        <p:spPr>
          <a:xfrm flipV="1">
            <a:off x="581040" y="2528640"/>
            <a:ext cx="3816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3"/>
          <p:cNvSpPr/>
          <p:nvPr/>
        </p:nvSpPr>
        <p:spPr>
          <a:xfrm flipH="1" flipV="1">
            <a:off x="1009440" y="2528640"/>
            <a:ext cx="3780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4"/>
          <p:cNvSpPr/>
          <p:nvPr/>
        </p:nvSpPr>
        <p:spPr>
          <a:xfrm flipV="1">
            <a:off x="1047600" y="2528640"/>
            <a:ext cx="27324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5"/>
          <p:cNvSpPr/>
          <p:nvPr/>
        </p:nvSpPr>
        <p:spPr>
          <a:xfrm flipH="1" flipV="1">
            <a:off x="1708200" y="2528640"/>
            <a:ext cx="272880" cy="142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AutoShape 39"/>
          <p:cNvSpPr/>
          <p:nvPr/>
        </p:nvSpPr>
        <p:spPr>
          <a:xfrm>
            <a:off x="1981080" y="952560"/>
            <a:ext cx="135000" cy="276120"/>
          </a:xfrm>
          <a:prstGeom prst="lightningBolt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960" bIns="39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40"/>
          <p:cNvSpPr/>
          <p:nvPr/>
        </p:nvSpPr>
        <p:spPr>
          <a:xfrm>
            <a:off x="374760" y="1311120"/>
            <a:ext cx="2151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41"/>
          <p:cNvSpPr/>
          <p:nvPr/>
        </p:nvSpPr>
        <p:spPr>
          <a:xfrm>
            <a:off x="365040" y="2006640"/>
            <a:ext cx="2151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2"/>
          <p:cNvSpPr/>
          <p:nvPr/>
        </p:nvSpPr>
        <p:spPr>
          <a:xfrm>
            <a:off x="365040" y="2679840"/>
            <a:ext cx="2151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43"/>
          <p:cNvSpPr/>
          <p:nvPr/>
        </p:nvSpPr>
        <p:spPr>
          <a:xfrm>
            <a:off x="581760" y="1951200"/>
            <a:ext cx="48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4"/>
          <p:cNvSpPr/>
          <p:nvPr/>
        </p:nvSpPr>
        <p:spPr>
          <a:xfrm>
            <a:off x="1232640" y="1951200"/>
            <a:ext cx="48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5"/>
          <p:cNvSpPr/>
          <p:nvPr/>
        </p:nvSpPr>
        <p:spPr>
          <a:xfrm>
            <a:off x="1927080" y="195408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½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6"/>
          <p:cNvSpPr/>
          <p:nvPr/>
        </p:nvSpPr>
        <p:spPr>
          <a:xfrm>
            <a:off x="581760" y="2629080"/>
            <a:ext cx="48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7"/>
          <p:cNvSpPr/>
          <p:nvPr/>
        </p:nvSpPr>
        <p:spPr>
          <a:xfrm>
            <a:off x="1232640" y="2629080"/>
            <a:ext cx="48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8"/>
          <p:cNvSpPr/>
          <p:nvPr/>
        </p:nvSpPr>
        <p:spPr>
          <a:xfrm>
            <a:off x="1927080" y="2631960"/>
            <a:ext cx="519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½ se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7"/>
          <p:cNvSpPr/>
          <p:nvPr/>
        </p:nvSpPr>
        <p:spPr>
          <a:xfrm>
            <a:off x="1982880" y="1603440"/>
            <a:ext cx="77760" cy="406440"/>
          </a:xfrm>
          <a:prstGeom prst="rect">
            <a:avLst/>
          </a:prstGeom>
          <a:solidFill>
            <a:srgbClr val="ff0000">
              <a:alpha val="70000"/>
            </a:srgbClr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7"/>
          <p:cNvSpPr/>
          <p:nvPr/>
        </p:nvSpPr>
        <p:spPr>
          <a:xfrm>
            <a:off x="1979640" y="2273400"/>
            <a:ext cx="76320" cy="406440"/>
          </a:xfrm>
          <a:prstGeom prst="rect">
            <a:avLst/>
          </a:prstGeom>
          <a:solidFill>
            <a:srgbClr val="ff0000">
              <a:alpha val="70000"/>
            </a:srgbClr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AutoShape 25"/>
          <p:cNvSpPr/>
          <p:nvPr/>
        </p:nvSpPr>
        <p:spPr>
          <a:xfrm>
            <a:off x="1986120" y="1701720"/>
            <a:ext cx="120600" cy="214560"/>
          </a:xfrm>
          <a:prstGeom prst="lightningBolt">
            <a:avLst/>
          </a:prstGeom>
          <a:solidFill>
            <a:srgbClr val="ffff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0880" bIns="2088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AutoShape 26"/>
          <p:cNvSpPr/>
          <p:nvPr/>
        </p:nvSpPr>
        <p:spPr>
          <a:xfrm>
            <a:off x="1973160" y="1733400"/>
            <a:ext cx="158760" cy="149400"/>
          </a:xfrm>
          <a:custGeom>
            <a:avLst/>
            <a:gdLst>
              <a:gd name="textAreaLeft" fmla="*/ 23040 w 158760"/>
              <a:gd name="textAreaRight" fmla="*/ 135720 w 158760"/>
              <a:gd name="textAreaTop" fmla="*/ 21600 h 149400"/>
              <a:gd name="textAreaBottom" fmla="*/ 127800 h 14940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8203" y="17745"/>
                </a:moveTo>
                <a:cubicBezTo>
                  <a:pt x="19969" y="15863"/>
                  <a:pt x="20952" y="13380"/>
                  <a:pt x="20952" y="10800"/>
                </a:cubicBezTo>
                <a:cubicBezTo>
                  <a:pt x="20952" y="5193"/>
                  <a:pt x="16406" y="648"/>
                  <a:pt x="10800" y="648"/>
                </a:cubicBezTo>
                <a:cubicBezTo>
                  <a:pt x="8219" y="647"/>
                  <a:pt x="5736" y="1630"/>
                  <a:pt x="3854" y="3396"/>
                </a:cubicBezTo>
                <a:lnTo>
                  <a:pt x="18203" y="17745"/>
                </a:lnTo>
                <a:close/>
                <a:moveTo>
                  <a:pt x="3396" y="3854"/>
                </a:moveTo>
                <a:cubicBezTo>
                  <a:pt x="1630" y="5736"/>
                  <a:pt x="647" y="8219"/>
                  <a:pt x="647" y="10799"/>
                </a:cubicBezTo>
                <a:cubicBezTo>
                  <a:pt x="648" y="16406"/>
                  <a:pt x="5193" y="20952"/>
                  <a:pt x="10800" y="20952"/>
                </a:cubicBezTo>
                <a:cubicBezTo>
                  <a:pt x="13380" y="20952"/>
                  <a:pt x="15863" y="19969"/>
                  <a:pt x="17745" y="18203"/>
                </a:cubicBezTo>
                <a:lnTo>
                  <a:pt x="3396" y="3854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"/>
          <p:cNvSpPr/>
          <p:nvPr/>
        </p:nvSpPr>
        <p:spPr>
          <a:xfrm>
            <a:off x="324000" y="3068640"/>
            <a:ext cx="381636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radigm design and timin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ear conditioning consisted of 16 CS+ trials where 10 were followed by a US, and 6 trials were not followed by a US (omitted US). Trials were intermixed with CS- trials that were never reinforced. Prior to the onset of each trial, a context image was displayed (an office with an unlit lamp). The main focus of this paper is the time after the offset of the CS, indicated in r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 Box 2"/>
          <p:cNvSpPr/>
          <p:nvPr/>
        </p:nvSpPr>
        <p:spPr>
          <a:xfrm>
            <a:off x="0" y="0"/>
            <a:ext cx="249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Group 3"/>
          <p:cNvGrpSpPr/>
          <p:nvPr/>
        </p:nvGrpSpPr>
        <p:grpSpPr>
          <a:xfrm>
            <a:off x="179280" y="503280"/>
            <a:ext cx="4160160" cy="2135520"/>
            <a:chOff x="179280" y="503280"/>
            <a:chExt cx="4160160" cy="2135520"/>
          </a:xfrm>
        </p:grpSpPr>
        <p:graphicFrame>
          <p:nvGraphicFramePr>
            <p:cNvPr id="93" name="Object 4"/>
            <p:cNvGraphicFramePr/>
            <p:nvPr/>
          </p:nvGraphicFramePr>
          <p:xfrm>
            <a:off x="250920" y="503280"/>
            <a:ext cx="3903480" cy="18842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94" name="Object 4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50920" y="503280"/>
                      <a:ext cx="3903480" cy="1884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5" name="Rectangle 5"/>
            <p:cNvSpPr/>
            <p:nvPr/>
          </p:nvSpPr>
          <p:spPr>
            <a:xfrm>
              <a:off x="577800" y="1187280"/>
              <a:ext cx="463680" cy="1081080"/>
            </a:xfrm>
            <a:prstGeom prst="rect">
              <a:avLst/>
            </a:prstGeom>
            <a:solidFill>
              <a:srgbClr val="c0c0c0">
                <a:alpha val="47000"/>
              </a:srgbClr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6"/>
            <p:cNvSpPr/>
            <p:nvPr/>
          </p:nvSpPr>
          <p:spPr>
            <a:xfrm>
              <a:off x="506520" y="849240"/>
              <a:ext cx="708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ontex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7"/>
            <p:cNvSpPr/>
            <p:nvPr/>
          </p:nvSpPr>
          <p:spPr>
            <a:xfrm>
              <a:off x="1298880" y="851040"/>
              <a:ext cx="46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u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8"/>
            <p:cNvSpPr/>
            <p:nvPr/>
          </p:nvSpPr>
          <p:spPr>
            <a:xfrm>
              <a:off x="2354040" y="2362320"/>
              <a:ext cx="1073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2-18 sec ITI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9"/>
            <p:cNvSpPr/>
            <p:nvPr/>
          </p:nvSpPr>
          <p:spPr>
            <a:xfrm>
              <a:off x="3459240" y="1673280"/>
              <a:ext cx="142920" cy="595080"/>
            </a:xfrm>
            <a:prstGeom prst="rect">
              <a:avLst/>
            </a:prstGeom>
            <a:solidFill>
              <a:srgbClr val="c0c0c0">
                <a:alpha val="47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0"/>
            <p:cNvSpPr/>
            <p:nvPr/>
          </p:nvSpPr>
          <p:spPr>
            <a:xfrm flipH="1">
              <a:off x="2736720" y="2268360"/>
              <a:ext cx="720720" cy="0"/>
            </a:xfrm>
            <a:prstGeom prst="line">
              <a:avLst/>
            </a:prstGeom>
            <a:ln w="32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1"/>
            <p:cNvSpPr/>
            <p:nvPr/>
          </p:nvSpPr>
          <p:spPr>
            <a:xfrm>
              <a:off x="3456000" y="1671480"/>
              <a:ext cx="3240" cy="596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12"/>
            <p:cNvSpPr/>
            <p:nvPr/>
          </p:nvSpPr>
          <p:spPr>
            <a:xfrm>
              <a:off x="649800" y="2362320"/>
              <a:ext cx="54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 se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AutoShape 13"/>
            <p:cNvSpPr/>
            <p:nvPr/>
          </p:nvSpPr>
          <p:spPr>
            <a:xfrm rot="16200000">
              <a:off x="733320" y="2112840"/>
              <a:ext cx="152640" cy="463680"/>
            </a:xfrm>
            <a:custGeom>
              <a:avLst/>
              <a:gdLst>
                <a:gd name="textAreaLeft" fmla="*/ 97560 w 152640"/>
                <a:gd name="textAreaRight" fmla="*/ 153000 w 152640"/>
                <a:gd name="textAreaTop" fmla="*/ 11880 h 463680"/>
                <a:gd name="textAreaBottom" fmla="*/ 451800 h 4636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 Box 14"/>
            <p:cNvSpPr/>
            <p:nvPr/>
          </p:nvSpPr>
          <p:spPr>
            <a:xfrm>
              <a:off x="1340280" y="2362320"/>
              <a:ext cx="546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 se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15"/>
            <p:cNvSpPr/>
            <p:nvPr/>
          </p:nvSpPr>
          <p:spPr>
            <a:xfrm>
              <a:off x="1830240" y="2362320"/>
              <a:ext cx="58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½ se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16"/>
            <p:cNvSpPr/>
            <p:nvPr/>
          </p:nvSpPr>
          <p:spPr>
            <a:xfrm>
              <a:off x="1041480" y="1130400"/>
              <a:ext cx="933480" cy="1137960"/>
            </a:xfrm>
            <a:prstGeom prst="rect">
              <a:avLst/>
            </a:prstGeom>
            <a:solidFill>
              <a:srgbClr val="808080">
                <a:alpha val="47000"/>
              </a:srgbClr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17"/>
            <p:cNvSpPr/>
            <p:nvPr/>
          </p:nvSpPr>
          <p:spPr>
            <a:xfrm>
              <a:off x="1976400" y="755640"/>
              <a:ext cx="82440" cy="1512720"/>
            </a:xfrm>
            <a:prstGeom prst="rect">
              <a:avLst/>
            </a:prstGeom>
            <a:solidFill>
              <a:srgbClr val="ff0000">
                <a:alpha val="70000"/>
              </a:srgbClr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AutoShape 18"/>
            <p:cNvSpPr/>
            <p:nvPr/>
          </p:nvSpPr>
          <p:spPr>
            <a:xfrm>
              <a:off x="1986120" y="1189080"/>
              <a:ext cx="120600" cy="214200"/>
            </a:xfrm>
            <a:prstGeom prst="lightningBolt">
              <a:avLst/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0520" bIns="205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AutoShape 19"/>
            <p:cNvSpPr/>
            <p:nvPr/>
          </p:nvSpPr>
          <p:spPr>
            <a:xfrm rot="16200000">
              <a:off x="1431720" y="1877760"/>
              <a:ext cx="152640" cy="933480"/>
            </a:xfrm>
            <a:custGeom>
              <a:avLst/>
              <a:gdLst>
                <a:gd name="textAreaLeft" fmla="*/ 97560 w 152640"/>
                <a:gd name="textAreaRight" fmla="*/ 153000 w 152640"/>
                <a:gd name="textAreaTop" fmla="*/ 24120 h 933480"/>
                <a:gd name="textAreaBottom" fmla="*/ 909360 h 933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AutoShape 20"/>
            <p:cNvSpPr/>
            <p:nvPr/>
          </p:nvSpPr>
          <p:spPr>
            <a:xfrm rot="16200000">
              <a:off x="1941120" y="2303280"/>
              <a:ext cx="152640" cy="82440"/>
            </a:xfrm>
            <a:custGeom>
              <a:avLst/>
              <a:gdLst>
                <a:gd name="textAreaLeft" fmla="*/ 97560 w 152640"/>
                <a:gd name="textAreaRight" fmla="*/ 153000 w 152640"/>
                <a:gd name="textAreaTop" fmla="*/ 1800 h 82440"/>
                <a:gd name="textAreaBottom" fmla="*/ 80640 h 824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2040" bIns="3204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AutoShape 21"/>
            <p:cNvSpPr/>
            <p:nvPr/>
          </p:nvSpPr>
          <p:spPr>
            <a:xfrm rot="16200000">
              <a:off x="2680920" y="1644480"/>
              <a:ext cx="152640" cy="1400040"/>
            </a:xfrm>
            <a:custGeom>
              <a:avLst/>
              <a:gdLst>
                <a:gd name="textAreaLeft" fmla="*/ 97560 w 152640"/>
                <a:gd name="textAreaRight" fmla="*/ 153000 w 152640"/>
                <a:gd name="textAreaTop" fmla="*/ 36360 h 1400040"/>
                <a:gd name="textAreaBottom" fmla="*/ 1363680 h 1400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 Box 22"/>
            <p:cNvSpPr/>
            <p:nvPr/>
          </p:nvSpPr>
          <p:spPr>
            <a:xfrm>
              <a:off x="2521440" y="777960"/>
              <a:ext cx="1221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S+ and sh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 Box 23"/>
            <p:cNvSpPr/>
            <p:nvPr/>
          </p:nvSpPr>
          <p:spPr>
            <a:xfrm>
              <a:off x="2531160" y="1427040"/>
              <a:ext cx="180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S+ and  omitted sh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 Box 24"/>
            <p:cNvSpPr/>
            <p:nvPr/>
          </p:nvSpPr>
          <p:spPr>
            <a:xfrm>
              <a:off x="2520360" y="1760400"/>
              <a:ext cx="139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S- and no sh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AutoShape 25"/>
            <p:cNvSpPr/>
            <p:nvPr/>
          </p:nvSpPr>
          <p:spPr>
            <a:xfrm>
              <a:off x="1986120" y="1477800"/>
              <a:ext cx="120600" cy="214560"/>
            </a:xfrm>
            <a:prstGeom prst="lightningBolt">
              <a:avLst/>
            </a:prstGeom>
            <a:solidFill>
              <a:srgbClr val="ffff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0880" bIns="2088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AutoShape 26"/>
            <p:cNvSpPr/>
            <p:nvPr/>
          </p:nvSpPr>
          <p:spPr>
            <a:xfrm>
              <a:off x="1973160" y="1509840"/>
              <a:ext cx="158760" cy="149040"/>
            </a:xfrm>
            <a:custGeom>
              <a:avLst/>
              <a:gdLst>
                <a:gd name="textAreaLeft" fmla="*/ 23760 w 158760"/>
                <a:gd name="textAreaRight" fmla="*/ 135000 w 158760"/>
                <a:gd name="textAreaTop" fmla="*/ 21960 h 149040"/>
                <a:gd name="textAreaBottom" fmla="*/ 127080 h 149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10800"/>
                  </a:moveTo>
                  <a:cubicBezTo>
                    <a:pt x="0" y="4835"/>
                    <a:pt x="4835" y="0"/>
                    <a:pt x="10800" y="0"/>
                  </a:cubicBezTo>
                  <a:cubicBezTo>
                    <a:pt x="16765" y="0"/>
                    <a:pt x="21600" y="4835"/>
                    <a:pt x="21600" y="10800"/>
                  </a:cubicBezTo>
                  <a:cubicBezTo>
                    <a:pt x="21600" y="16765"/>
                    <a:pt x="16765" y="21600"/>
                    <a:pt x="10800" y="21600"/>
                  </a:cubicBezTo>
                  <a:cubicBezTo>
                    <a:pt x="4835" y="21600"/>
                    <a:pt x="0" y="16765"/>
                    <a:pt x="0" y="10800"/>
                  </a:cubicBezTo>
                  <a:close/>
                  <a:moveTo>
                    <a:pt x="18203" y="17745"/>
                  </a:moveTo>
                  <a:cubicBezTo>
                    <a:pt x="19969" y="15863"/>
                    <a:pt x="20952" y="13380"/>
                    <a:pt x="20952" y="10800"/>
                  </a:cubicBezTo>
                  <a:cubicBezTo>
                    <a:pt x="20952" y="5193"/>
                    <a:pt x="16406" y="648"/>
                    <a:pt x="10800" y="648"/>
                  </a:cubicBezTo>
                  <a:cubicBezTo>
                    <a:pt x="8219" y="647"/>
                    <a:pt x="5736" y="1630"/>
                    <a:pt x="3854" y="3396"/>
                  </a:cubicBezTo>
                  <a:lnTo>
                    <a:pt x="18203" y="17745"/>
                  </a:lnTo>
                  <a:close/>
                  <a:moveTo>
                    <a:pt x="3396" y="3854"/>
                  </a:moveTo>
                  <a:cubicBezTo>
                    <a:pt x="1630" y="5736"/>
                    <a:pt x="647" y="8219"/>
                    <a:pt x="647" y="10799"/>
                  </a:cubicBezTo>
                  <a:cubicBezTo>
                    <a:pt x="648" y="16406"/>
                    <a:pt x="5193" y="20952"/>
                    <a:pt x="10800" y="20952"/>
                  </a:cubicBezTo>
                  <a:cubicBezTo>
                    <a:pt x="13380" y="20952"/>
                    <a:pt x="15863" y="19969"/>
                    <a:pt x="17745" y="18203"/>
                  </a:cubicBezTo>
                  <a:lnTo>
                    <a:pt x="3396" y="3854"/>
                  </a:lnTo>
                  <a:close/>
                </a:path>
              </a:pathLst>
            </a:cu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28"/>
            <p:cNvSpPr/>
            <p:nvPr/>
          </p:nvSpPr>
          <p:spPr>
            <a:xfrm rot="16200000">
              <a:off x="-279360" y="1435320"/>
              <a:ext cx="1194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icrosiemens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½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8" name="TextBox 27"/>
          <p:cNvSpPr/>
          <p:nvPr/>
        </p:nvSpPr>
        <p:spPr>
          <a:xfrm>
            <a:off x="324000" y="3068640"/>
            <a:ext cx="381636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kin conductance responses within three different trials in one representative subjec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quare root transformed skin conductance levels during three representative trials beginning with context (in light gray), cue (gray) and US or omitted US (red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ext Box 2"/>
          <p:cNvSpPr/>
          <p:nvPr/>
        </p:nvSpPr>
        <p:spPr>
          <a:xfrm>
            <a:off x="0" y="0"/>
            <a:ext cx="249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0" name="Group 3"/>
          <p:cNvGrpSpPr/>
          <p:nvPr/>
        </p:nvGrpSpPr>
        <p:grpSpPr>
          <a:xfrm>
            <a:off x="466560" y="620640"/>
            <a:ext cx="4824360" cy="1930320"/>
            <a:chOff x="466560" y="620640"/>
            <a:chExt cx="4824360" cy="1930320"/>
          </a:xfrm>
        </p:grpSpPr>
        <p:graphicFrame>
          <p:nvGraphicFramePr>
            <p:cNvPr id="121" name="Object 4"/>
            <p:cNvGraphicFramePr/>
            <p:nvPr/>
          </p:nvGraphicFramePr>
          <p:xfrm>
            <a:off x="466560" y="620640"/>
            <a:ext cx="4824360" cy="193032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122" name="Object 4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466560" y="620640"/>
                      <a:ext cx="4824360" cy="1930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23" name="Text Box 6"/>
            <p:cNvSpPr/>
            <p:nvPr/>
          </p:nvSpPr>
          <p:spPr>
            <a:xfrm>
              <a:off x="1483200" y="836640"/>
              <a:ext cx="2006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Conditioned respons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7"/>
            <p:cNvSpPr/>
            <p:nvPr/>
          </p:nvSpPr>
          <p:spPr>
            <a:xfrm rot="16200000">
              <a:off x="21960" y="1463760"/>
              <a:ext cx="1194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icrosiemens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½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5" name="TextBox 6"/>
          <p:cNvSpPr/>
          <p:nvPr/>
        </p:nvSpPr>
        <p:spPr>
          <a:xfrm>
            <a:off x="324000" y="3068640"/>
            <a:ext cx="3816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kin conductance responses to the CS+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quare root transformed skin conductance responses in PTSD and TENC subjects throughout the 16 CS+ trials in the experime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 Box 2"/>
          <p:cNvSpPr/>
          <p:nvPr/>
        </p:nvSpPr>
        <p:spPr>
          <a:xfrm>
            <a:off x="0" y="0"/>
            <a:ext cx="249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 S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27" name="Object 3"/>
          <p:cNvGraphicFramePr/>
          <p:nvPr/>
        </p:nvGraphicFramePr>
        <p:xfrm>
          <a:off x="611280" y="765000"/>
          <a:ext cx="2830320" cy="18813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128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11280" y="765000"/>
                    <a:ext cx="2830320" cy="1881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9" name="Text Box 5"/>
          <p:cNvSpPr/>
          <p:nvPr/>
        </p:nvSpPr>
        <p:spPr>
          <a:xfrm>
            <a:off x="1120680" y="907920"/>
            <a:ext cx="1462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hock respon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6"/>
          <p:cNvSpPr/>
          <p:nvPr/>
        </p:nvSpPr>
        <p:spPr>
          <a:xfrm rot="16200000">
            <a:off x="101520" y="1544760"/>
            <a:ext cx="119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icrosiemens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½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5"/>
          <p:cNvSpPr/>
          <p:nvPr/>
        </p:nvSpPr>
        <p:spPr>
          <a:xfrm>
            <a:off x="324000" y="3068640"/>
            <a:ext cx="3816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kin conductance responses to the U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quare root transformed skin conductance responses in PTSD and TENC subjects throughout the 10 US in the experime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Text Box 2"/>
          <p:cNvSpPr/>
          <p:nvPr/>
        </p:nvSpPr>
        <p:spPr>
          <a:xfrm>
            <a:off x="0" y="0"/>
            <a:ext cx="249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Figure S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Group 3"/>
          <p:cNvGrpSpPr/>
          <p:nvPr/>
        </p:nvGrpSpPr>
        <p:grpSpPr>
          <a:xfrm>
            <a:off x="545760" y="826920"/>
            <a:ext cx="3243600" cy="1881360"/>
            <a:chOff x="545760" y="826920"/>
            <a:chExt cx="3243600" cy="1881360"/>
          </a:xfrm>
        </p:grpSpPr>
        <p:graphicFrame>
          <p:nvGraphicFramePr>
            <p:cNvPr id="134" name="Object 4"/>
            <p:cNvGraphicFramePr/>
            <p:nvPr/>
          </p:nvGraphicFramePr>
          <p:xfrm>
            <a:off x="611280" y="826920"/>
            <a:ext cx="3178080" cy="188136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135" name="Object 4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611280" y="826920"/>
                      <a:ext cx="3178080" cy="1881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36" name="Text Box 6"/>
            <p:cNvSpPr/>
            <p:nvPr/>
          </p:nvSpPr>
          <p:spPr>
            <a:xfrm>
              <a:off x="545760" y="1004760"/>
              <a:ext cx="2108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Omitted shock respons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 Box 7"/>
            <p:cNvSpPr/>
            <p:nvPr/>
          </p:nvSpPr>
          <p:spPr>
            <a:xfrm rot="16200000">
              <a:off x="95040" y="1646280"/>
              <a:ext cx="1194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icrosiemens</a:t>
              </a:r>
              <a:r>
                <a:rPr b="0" lang="en-US" sz="1200" spc="-1" strike="noStrike" baseline="30000">
                  <a:solidFill>
                    <a:srgbClr val="000000"/>
                  </a:solidFill>
                  <a:latin typeface="Arial"/>
                </a:rPr>
                <a:t>½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8" name="TextBox 6"/>
          <p:cNvSpPr/>
          <p:nvPr/>
        </p:nvSpPr>
        <p:spPr>
          <a:xfrm>
            <a:off x="324000" y="3068640"/>
            <a:ext cx="38163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kin conductance responses to the omitted U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quare root transformed skin conductance responses in PTSD and TENC subjects throughout the 6 omitted US in the experime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4T20:21:00Z</dcterms:created>
  <dc:creator>clas.linnman</dc:creator>
  <dc:description/>
  <dc:language>en-US</dc:language>
  <cp:lastModifiedBy>Clas Linnman</cp:lastModifiedBy>
  <dcterms:modified xsi:type="dcterms:W3CDTF">2011-06-23T13:35:50Z</dcterms:modified>
  <cp:revision>5</cp:revision>
  <dc:subject/>
  <dc:title>Bild 1</dc:title>
</cp:coreProperties>
</file>